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9"/>
    <p:restoredTop sz="96208"/>
  </p:normalViewPr>
  <p:slideViewPr>
    <p:cSldViewPr snapToGrid="0" snapToObjects="1">
      <p:cViewPr varScale="1">
        <p:scale>
          <a:sx n="116" d="100"/>
          <a:sy n="116" d="100"/>
        </p:scale>
        <p:origin x="192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95674-4496-0E4F-9844-62A529501A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96FAF3-C57D-CC4D-8288-A215CC301D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09E6CC-4FBD-C54F-A017-765E64691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12A41-7DCA-BB44-88B5-EB507A07A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FAE6B-3ABA-E148-AAAE-02C55F4C8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843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15427-3C5C-D947-A73E-1F35BD33F1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9078C3-1732-EE48-8D01-1E2A1F7A5A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483BAA-609E-AC45-91D6-F44C3B163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7DCFD-F63F-9244-9EC9-E0B7A0E82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6CC5E6-F043-0A44-BD6B-931202B7B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674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418217-FE90-4F47-BC63-189A29FE25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8911E7-71F9-5B46-B6A2-7493C32457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06B786-7EF3-7843-8171-9191DBEC8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53975D-6258-4247-B7E7-FC25B3C86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87ED0-D7E1-124B-B3A2-01F615CBB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42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AFAA3-226E-7446-B56D-265265BF1D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7ED25A-28B2-9142-B98D-227A0B0C36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C9FC40-C8CB-D245-95CE-9D44EECD9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5C52B8-3955-7F4B-8175-1D37C7113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19011-48CA-0F45-8948-C31751E4F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514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60E7B-0C74-B740-8E6C-A59E2B3C1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C56D93-8F83-1D4E-A7B0-5F56B24CC7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11E4AB-7891-A24F-A8FE-20AFAB5D1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355C8-044D-B643-AD1C-50F4C09A4D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A525A2-F22A-5043-BC47-BB1F3F8FB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798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CE206-DE1F-304D-83CB-BDEEEDDF90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080B9F-5178-9840-9448-8B0AAAB8CF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AB3B27-380D-B44A-96F2-A08919B974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3E6A0D-4F24-E946-801E-F19F7C4CD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B87E96-6732-1A46-AED8-78AF971A1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342BE8-CDF8-7B4F-BE3D-3D55311E0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107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84D0B2-EF1A-DB4C-92BC-4BC93FB60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E3EABD-7E06-594D-A588-7065A2B681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0BADC-8EB8-9343-A9F8-56CF0EA5F9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44BC09-FD4F-BA42-BE78-4AD81C4DB2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E0089F-0EC6-334F-A988-A52DD56C6E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E16BB0-D485-8642-AFEF-A8F332A9E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6CC615-2313-EA4D-9D41-CD2C6917E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786051-1A04-E148-9C12-8B8B30B79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826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7452AD-9322-0D46-92DA-55B11873A0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600684-143B-414C-BAA0-CC56A96D8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29020C-D5BB-C644-B4C0-4DE4506FB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E647A3-E05A-3145-A59C-5EE2C5A8A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114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BFC780-9AF4-2543-826C-39C96C402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1C0842-CB97-594B-B863-CDBC09C7A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78627B-36C3-0049-9C7F-FE8F48C03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877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A4113-5DA2-FE41-81D3-270946F3C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7BC623-DBF8-7B4A-A061-4567EC514A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D44B57-A2AC-A047-A6C2-1DA4BE7847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F70FFD-EBEA-2442-B7F3-E055C8F91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CAFE85-15BC-7742-9806-B5EC75748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284CDD-50F5-3843-9DB7-12362D0A8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628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7F06F-2FD6-DC4C-B4AE-45D48B606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EDEFBF-0E7C-224E-BC84-3BDD296F66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E84C9D-B2ED-3D41-A6B0-3216D3EBA4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361CEC-05B1-2C44-A1C9-AD19BD28A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56BA12-41BB-C847-8B7B-27200ED44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9FB24-9128-9940-BA2F-6608FDC663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76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19C910-BA44-6145-AEA3-1EA092BD0C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67A7E1-F865-5641-88C0-910885D66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226D43-2929-4449-8257-5AF60B6AD1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984DE-B9C1-9547-A55C-57DC40C2FEC9}" type="datetimeFigureOut">
              <a:rPr lang="en-US" smtClean="0"/>
              <a:t>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FDFA08-A226-304A-AC8A-593B04C8D5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6F4618-FD7F-5142-8C34-B91640D95F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84599-14B4-D047-80BA-63C904B4EE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41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88EE1F6-A639-3D4D-9039-32B5253F3CF1}"/>
              </a:ext>
            </a:extLst>
          </p:cNvPr>
          <p:cNvSpPr/>
          <p:nvPr/>
        </p:nvSpPr>
        <p:spPr>
          <a:xfrm>
            <a:off x="217487" y="70452"/>
            <a:ext cx="1100328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>
                <a:latin typeface="Times New Roman" panose="02020603050405020304" pitchFamily="18" charset="0"/>
                <a:ea typeface="Times New Roman" panose="02020603050405020304" pitchFamily="18" charset="0"/>
              </a:rPr>
              <a:t>Figure S5: </a:t>
            </a: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Adjusted overall survival by cancer stage and (B) adjusted progression-free survival by cancer stage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00E42CE-BBF4-2742-A5C0-9C50F73E98B7}"/>
              </a:ext>
            </a:extLst>
          </p:cNvPr>
          <p:cNvSpPr/>
          <p:nvPr/>
        </p:nvSpPr>
        <p:spPr>
          <a:xfrm>
            <a:off x="191466" y="1161785"/>
            <a:ext cx="5748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12F16E3-CE6C-5342-A772-35AD903EE4B6}"/>
              </a:ext>
            </a:extLst>
          </p:cNvPr>
          <p:cNvSpPr/>
          <p:nvPr/>
        </p:nvSpPr>
        <p:spPr>
          <a:xfrm>
            <a:off x="6095217" y="1161785"/>
            <a:ext cx="5748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FD9EC61-C539-7647-B824-F572769E03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0090" y="1420165"/>
            <a:ext cx="5029200" cy="5029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CAB1F9F-81C1-7545-A570-8AFD70969F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421" y="1420165"/>
            <a:ext cx="50292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0489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ran, Thomas</dc:creator>
  <cp:lastModifiedBy>Curran, Thomas</cp:lastModifiedBy>
  <cp:revision>3</cp:revision>
  <dcterms:created xsi:type="dcterms:W3CDTF">2020-10-03T03:56:14Z</dcterms:created>
  <dcterms:modified xsi:type="dcterms:W3CDTF">2021-01-13T15:16:59Z</dcterms:modified>
</cp:coreProperties>
</file>